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469AC-0A3C-4606-A435-45BF23265F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9580F-A04B-4618-A705-AB48377333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50F0C-3EDA-4503-B31A-08CA25AA3C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768DF-ADAA-4FB6-83AD-082924B5FF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AB808-A117-4996-811A-481C20EBC2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D0041-A7C0-4F2E-A0A4-D706B03BD4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A39E2-5817-483F-BB86-2207347866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68950-3A30-4AFE-8972-E62CFB5E7F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30C5D-ABA7-4ADD-8098-1C4A71E4E7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4E68E-054B-4C67-B897-149E8E3683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16F1A-A6B2-4369-92AF-70058FF320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84AD8-2E60-43A6-BCAF-7ACF556A06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11C87E-CD3E-483E-BCFC-8B7C404A4B58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3"/>
          <p:cNvSpPr/>
          <p:nvPr/>
        </p:nvSpPr>
        <p:spPr>
          <a:xfrm>
            <a:off x="1066680" y="304920"/>
            <a:ext cx="6858000" cy="103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information - Figure 1: Expression levels of 13 miRNA measured by qRT-PCR in 3 ATC studied by microarrays and in 3 ATC independant or obtained from the literature. The microarray expressions are included for comparision. Log</a:t>
            </a:r>
            <a:r>
              <a:rPr b="0" lang="en-US" sz="1200" spc="-1" strike="noStrike" baseline="-30000">
                <a:solidFill>
                  <a:srgbClr val="000000"/>
                </a:solidFill>
                <a:latin typeface="Times New (W1)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atios represent the expression ratios of the genes in the tumors versus the normal tissu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Groupe 5"/>
          <p:cNvGrpSpPr/>
          <p:nvPr/>
        </p:nvGrpSpPr>
        <p:grpSpPr>
          <a:xfrm>
            <a:off x="-39600" y="-1971720"/>
            <a:ext cx="9902880" cy="7764480"/>
            <a:chOff x="-39600" y="-1971720"/>
            <a:chExt cx="9902880" cy="7764480"/>
          </a:xfrm>
        </p:grpSpPr>
        <p:graphicFrame>
          <p:nvGraphicFramePr>
            <p:cNvPr id="43" name="Object 44"/>
            <p:cNvGraphicFramePr/>
            <p:nvPr/>
          </p:nvGraphicFramePr>
          <p:xfrm>
            <a:off x="357480" y="1287000"/>
            <a:ext cx="9505800" cy="45057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4" name="Object 4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57480" y="1287000"/>
                      <a:ext cx="9505800" cy="4505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5" name="Rectangle 3"/>
            <p:cNvSpPr/>
            <p:nvPr/>
          </p:nvSpPr>
          <p:spPr>
            <a:xfrm>
              <a:off x="-39600" y="-1971720"/>
              <a:ext cx="6853320" cy="966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6" name="Groupe 7"/>
          <p:cNvGrpSpPr/>
          <p:nvPr/>
        </p:nvGrpSpPr>
        <p:grpSpPr>
          <a:xfrm>
            <a:off x="1197000" y="1359000"/>
            <a:ext cx="5535720" cy="1069920"/>
            <a:chOff x="1197000" y="1359000"/>
            <a:chExt cx="5535720" cy="1069920"/>
          </a:xfrm>
        </p:grpSpPr>
        <p:sp>
          <p:nvSpPr>
            <p:cNvPr id="47" name="Rectangle 6"/>
            <p:cNvSpPr/>
            <p:nvPr/>
          </p:nvSpPr>
          <p:spPr>
            <a:xfrm>
              <a:off x="1197000" y="1359000"/>
              <a:ext cx="5535720" cy="863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8" name="Groupe 2"/>
            <p:cNvGrpSpPr/>
            <p:nvPr/>
          </p:nvGrpSpPr>
          <p:grpSpPr>
            <a:xfrm>
              <a:off x="1197000" y="1438560"/>
              <a:ext cx="5088960" cy="990360"/>
              <a:chOff x="1197000" y="1438560"/>
              <a:chExt cx="5088960" cy="990360"/>
            </a:xfrm>
          </p:grpSpPr>
          <p:grpSp>
            <p:nvGrpSpPr>
              <p:cNvPr id="49" name="Group 42"/>
              <p:cNvGrpSpPr/>
              <p:nvPr/>
            </p:nvGrpSpPr>
            <p:grpSpPr>
              <a:xfrm>
                <a:off x="1197000" y="1438560"/>
                <a:ext cx="4300200" cy="990000"/>
                <a:chOff x="1197000" y="1438560"/>
                <a:chExt cx="4300200" cy="990000"/>
              </a:xfrm>
            </p:grpSpPr>
            <p:grpSp>
              <p:nvGrpSpPr>
                <p:cNvPr id="50" name="Group 29"/>
                <p:cNvGrpSpPr/>
                <p:nvPr/>
              </p:nvGrpSpPr>
              <p:grpSpPr>
                <a:xfrm>
                  <a:off x="1197000" y="1592280"/>
                  <a:ext cx="304560" cy="835920"/>
                  <a:chOff x="1197000" y="1592280"/>
                  <a:chExt cx="304560" cy="835920"/>
                </a:xfrm>
              </p:grpSpPr>
              <p:sp>
                <p:nvSpPr>
                  <p:cNvPr id="51" name="Text Box 7"/>
                  <p:cNvSpPr/>
                  <p:nvPr/>
                </p:nvSpPr>
                <p:spPr>
                  <a:xfrm rot="16200000">
                    <a:off x="987480" y="1815480"/>
                    <a:ext cx="723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51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52" name="AutoShape 18"/>
                  <p:cNvSpPr/>
                  <p:nvPr/>
                </p:nvSpPr>
                <p:spPr>
                  <a:xfrm rot="5400000">
                    <a:off x="1311120" y="223776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53" name="Group 30"/>
                <p:cNvGrpSpPr/>
                <p:nvPr/>
              </p:nvGrpSpPr>
              <p:grpSpPr>
                <a:xfrm>
                  <a:off x="1604520" y="1592280"/>
                  <a:ext cx="304920" cy="835920"/>
                  <a:chOff x="1604520" y="1592280"/>
                  <a:chExt cx="304920" cy="835920"/>
                </a:xfrm>
              </p:grpSpPr>
              <p:sp>
                <p:nvSpPr>
                  <p:cNvPr id="54" name="Text Box 8"/>
                  <p:cNvSpPr/>
                  <p:nvPr/>
                </p:nvSpPr>
                <p:spPr>
                  <a:xfrm rot="16200000">
                    <a:off x="1395720" y="1815480"/>
                    <a:ext cx="723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14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55" name="AutoShape 19"/>
                  <p:cNvSpPr/>
                  <p:nvPr/>
                </p:nvSpPr>
                <p:spPr>
                  <a:xfrm rot="5400000">
                    <a:off x="1719000" y="2237760"/>
                    <a:ext cx="75960" cy="30492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920"/>
                      <a:gd name="textAreaBottom" fmla="*/ 297000 h 304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56" name="Group 31"/>
                <p:cNvGrpSpPr/>
                <p:nvPr/>
              </p:nvGrpSpPr>
              <p:grpSpPr>
                <a:xfrm>
                  <a:off x="2011320" y="1515960"/>
                  <a:ext cx="304560" cy="912240"/>
                  <a:chOff x="2011320" y="1515960"/>
                  <a:chExt cx="304560" cy="912240"/>
                </a:xfrm>
              </p:grpSpPr>
              <p:sp>
                <p:nvSpPr>
                  <p:cNvPr id="57" name="Text Box 14"/>
                  <p:cNvSpPr/>
                  <p:nvPr/>
                </p:nvSpPr>
                <p:spPr>
                  <a:xfrm rot="16200000">
                    <a:off x="1765440" y="1777320"/>
                    <a:ext cx="7995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125b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58" name="AutoShape 20"/>
                  <p:cNvSpPr/>
                  <p:nvPr/>
                </p:nvSpPr>
                <p:spPr>
                  <a:xfrm rot="5400000">
                    <a:off x="2125440" y="223776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59" name="Group 32"/>
                <p:cNvGrpSpPr/>
                <p:nvPr/>
              </p:nvGrpSpPr>
              <p:grpSpPr>
                <a:xfrm>
                  <a:off x="2386080" y="1600920"/>
                  <a:ext cx="318600" cy="827280"/>
                  <a:chOff x="2386080" y="1600920"/>
                  <a:chExt cx="318600" cy="827280"/>
                </a:xfrm>
              </p:grpSpPr>
              <p:sp>
                <p:nvSpPr>
                  <p:cNvPr id="60" name="Text Box 9"/>
                  <p:cNvSpPr/>
                  <p:nvPr/>
                </p:nvSpPr>
                <p:spPr>
                  <a:xfrm rot="16200000">
                    <a:off x="2167200" y="1819800"/>
                    <a:ext cx="714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30a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61" name="AutoShape 21"/>
                  <p:cNvSpPr/>
                  <p:nvPr/>
                </p:nvSpPr>
                <p:spPr>
                  <a:xfrm rot="5400000">
                    <a:off x="2514240" y="2237760"/>
                    <a:ext cx="75960" cy="30492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920"/>
                      <a:gd name="textAreaBottom" fmla="*/ 297000 h 304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62" name="Group 33"/>
                <p:cNvGrpSpPr/>
                <p:nvPr/>
              </p:nvGrpSpPr>
              <p:grpSpPr>
                <a:xfrm>
                  <a:off x="2805120" y="1804680"/>
                  <a:ext cx="304560" cy="623520"/>
                  <a:chOff x="2805120" y="1804680"/>
                  <a:chExt cx="304560" cy="623520"/>
                </a:xfrm>
              </p:grpSpPr>
              <p:sp>
                <p:nvSpPr>
                  <p:cNvPr id="63" name="Text Box 15"/>
                  <p:cNvSpPr/>
                  <p:nvPr/>
                </p:nvSpPr>
                <p:spPr>
                  <a:xfrm rot="16200000">
                    <a:off x="2702520" y="1921320"/>
                    <a:ext cx="5097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let-7f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64" name="AutoShape 22"/>
                  <p:cNvSpPr/>
                  <p:nvPr/>
                </p:nvSpPr>
                <p:spPr>
                  <a:xfrm rot="5400000">
                    <a:off x="2919240" y="223776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65" name="Group 34"/>
                <p:cNvGrpSpPr/>
                <p:nvPr/>
              </p:nvGrpSpPr>
              <p:grpSpPr>
                <a:xfrm>
                  <a:off x="3204720" y="1779120"/>
                  <a:ext cx="304920" cy="649080"/>
                  <a:chOff x="3204720" y="1779120"/>
                  <a:chExt cx="304920" cy="649080"/>
                </a:xfrm>
              </p:grpSpPr>
              <p:sp>
                <p:nvSpPr>
                  <p:cNvPr id="66" name="Text Box 16"/>
                  <p:cNvSpPr/>
                  <p:nvPr/>
                </p:nvSpPr>
                <p:spPr>
                  <a:xfrm rot="16200000">
                    <a:off x="3091320" y="1908720"/>
                    <a:ext cx="535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let-7g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67" name="AutoShape 23"/>
                  <p:cNvSpPr/>
                  <p:nvPr/>
                </p:nvSpPr>
                <p:spPr>
                  <a:xfrm rot="5400000">
                    <a:off x="3319200" y="2237760"/>
                    <a:ext cx="75960" cy="30492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920"/>
                      <a:gd name="textAreaBottom" fmla="*/ 297000 h 304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68" name="Group 35"/>
                <p:cNvGrpSpPr/>
                <p:nvPr/>
              </p:nvGrpSpPr>
              <p:grpSpPr>
                <a:xfrm>
                  <a:off x="3598920" y="1592280"/>
                  <a:ext cx="304560" cy="835920"/>
                  <a:chOff x="3598920" y="1592280"/>
                  <a:chExt cx="304560" cy="835920"/>
                </a:xfrm>
              </p:grpSpPr>
              <p:sp>
                <p:nvSpPr>
                  <p:cNvPr id="69" name="Text Box 17"/>
                  <p:cNvSpPr/>
                  <p:nvPr/>
                </p:nvSpPr>
                <p:spPr>
                  <a:xfrm rot="16200000">
                    <a:off x="3389400" y="1815480"/>
                    <a:ext cx="723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14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0" name="AutoShape 24"/>
                  <p:cNvSpPr/>
                  <p:nvPr/>
                </p:nvSpPr>
                <p:spPr>
                  <a:xfrm rot="5400000">
                    <a:off x="3713040" y="223776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71" name="Group 36"/>
                <p:cNvGrpSpPr/>
                <p:nvPr/>
              </p:nvGrpSpPr>
              <p:grpSpPr>
                <a:xfrm>
                  <a:off x="4008240" y="1438560"/>
                  <a:ext cx="304560" cy="990000"/>
                  <a:chOff x="4008240" y="1438560"/>
                  <a:chExt cx="304560" cy="990000"/>
                </a:xfrm>
              </p:grpSpPr>
              <p:sp>
                <p:nvSpPr>
                  <p:cNvPr id="72" name="Text Box 10"/>
                  <p:cNvSpPr/>
                  <p:nvPr/>
                </p:nvSpPr>
                <p:spPr>
                  <a:xfrm rot="16200000">
                    <a:off x="3722760" y="1739520"/>
                    <a:ext cx="8787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148b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3" name="AutoShape 25"/>
                  <p:cNvSpPr/>
                  <p:nvPr/>
                </p:nvSpPr>
                <p:spPr>
                  <a:xfrm rot="5400000">
                    <a:off x="4122360" y="223812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74" name="Group 37"/>
                <p:cNvGrpSpPr/>
                <p:nvPr/>
              </p:nvGrpSpPr>
              <p:grpSpPr>
                <a:xfrm>
                  <a:off x="4407840" y="1515960"/>
                  <a:ext cx="304920" cy="912240"/>
                  <a:chOff x="4407840" y="1515960"/>
                  <a:chExt cx="304920" cy="912240"/>
                </a:xfrm>
              </p:grpSpPr>
              <p:sp>
                <p:nvSpPr>
                  <p:cNvPr id="75" name="Text Box 11"/>
                  <p:cNvSpPr/>
                  <p:nvPr/>
                </p:nvSpPr>
                <p:spPr>
                  <a:xfrm rot="16200000">
                    <a:off x="4160880" y="1777320"/>
                    <a:ext cx="7995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200b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6" name="AutoShape 26"/>
                  <p:cNvSpPr/>
                  <p:nvPr/>
                </p:nvSpPr>
                <p:spPr>
                  <a:xfrm rot="5400000">
                    <a:off x="4522320" y="2237760"/>
                    <a:ext cx="75960" cy="30492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920"/>
                      <a:gd name="textAreaBottom" fmla="*/ 297000 h 304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77" name="Group 38"/>
                <p:cNvGrpSpPr/>
                <p:nvPr/>
              </p:nvGrpSpPr>
              <p:grpSpPr>
                <a:xfrm>
                  <a:off x="4790520" y="1600920"/>
                  <a:ext cx="304920" cy="827280"/>
                  <a:chOff x="4790520" y="1600920"/>
                  <a:chExt cx="304920" cy="827280"/>
                </a:xfrm>
              </p:grpSpPr>
              <p:sp>
                <p:nvSpPr>
                  <p:cNvPr id="78" name="Text Box 12"/>
                  <p:cNvSpPr/>
                  <p:nvPr/>
                </p:nvSpPr>
                <p:spPr>
                  <a:xfrm rot="16200000">
                    <a:off x="4586400" y="1819800"/>
                    <a:ext cx="714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29a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79" name="AutoShape 27"/>
                  <p:cNvSpPr/>
                  <p:nvPr/>
                </p:nvSpPr>
                <p:spPr>
                  <a:xfrm rot="5400000">
                    <a:off x="4905000" y="2237760"/>
                    <a:ext cx="75960" cy="30492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920"/>
                      <a:gd name="textAreaBottom" fmla="*/ 297000 h 3049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  <p:grpSp>
              <p:nvGrpSpPr>
                <p:cNvPr id="80" name="Group 39"/>
                <p:cNvGrpSpPr/>
                <p:nvPr/>
              </p:nvGrpSpPr>
              <p:grpSpPr>
                <a:xfrm>
                  <a:off x="5192640" y="1600920"/>
                  <a:ext cx="304560" cy="827280"/>
                  <a:chOff x="5192640" y="1600920"/>
                  <a:chExt cx="304560" cy="827280"/>
                </a:xfrm>
              </p:grpSpPr>
              <p:sp>
                <p:nvSpPr>
                  <p:cNvPr id="81" name="Text Box 13"/>
                  <p:cNvSpPr/>
                  <p:nvPr/>
                </p:nvSpPr>
                <p:spPr>
                  <a:xfrm rot="16200000">
                    <a:off x="4987800" y="1819800"/>
                    <a:ext cx="7142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BE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miR-30e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sp>
                <p:nvSpPr>
                  <p:cNvPr id="82" name="AutoShape 28"/>
                  <p:cNvSpPr/>
                  <p:nvPr/>
                </p:nvSpPr>
                <p:spPr>
                  <a:xfrm rot="5400000">
                    <a:off x="5306760" y="2237760"/>
                    <a:ext cx="75960" cy="304560"/>
                  </a:xfrm>
                  <a:custGeom>
                    <a:avLst/>
                    <a:gdLst>
                      <a:gd name="textAreaLeft" fmla="*/ 48600 w 75960"/>
                      <a:gd name="textAreaRight" fmla="*/ 76320 w 75960"/>
                      <a:gd name="textAreaTop" fmla="*/ 7920 h 304560"/>
                      <a:gd name="textAreaBottom" fmla="*/ 296640 h 3045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6200" y="0"/>
                          <a:pt x="10800" y="900"/>
                          <a:pt x="10800" y="1800"/>
                        </a:cubicBezTo>
                        <a:lnTo>
                          <a:pt x="10800" y="9000"/>
                        </a:lnTo>
                        <a:cubicBezTo>
                          <a:pt x="10800" y="9900"/>
                          <a:pt x="5400" y="10800"/>
                          <a:pt x="0" y="10800"/>
                        </a:cubicBezTo>
                        <a:cubicBezTo>
                          <a:pt x="5400" y="10800"/>
                          <a:pt x="10800" y="11700"/>
                          <a:pt x="10800" y="12600"/>
                        </a:cubicBezTo>
                        <a:lnTo>
                          <a:pt x="10800" y="19800"/>
                        </a:lnTo>
                        <a:cubicBezTo>
                          <a:pt x="10800" y="20700"/>
                          <a:pt x="16200" y="21600"/>
                          <a:pt x="21600" y="21600"/>
                        </a:cubicBez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</p:grpSp>
          </p:grpSp>
          <p:sp>
            <p:nvSpPr>
              <p:cNvPr id="83" name="Text Box 13"/>
              <p:cNvSpPr/>
              <p:nvPr/>
            </p:nvSpPr>
            <p:spPr>
              <a:xfrm rot="16200000">
                <a:off x="5365080" y="1846080"/>
                <a:ext cx="723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BE" sz="1200" spc="-1" strike="noStrike">
                    <a:solidFill>
                      <a:srgbClr val="000000"/>
                    </a:solidFill>
                    <a:latin typeface="Times New Roman"/>
                  </a:rPr>
                  <a:t>miR-34b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AutoShape 28"/>
              <p:cNvSpPr/>
              <p:nvPr/>
            </p:nvSpPr>
            <p:spPr>
              <a:xfrm rot="5400000">
                <a:off x="5689800" y="2238480"/>
                <a:ext cx="75960" cy="304560"/>
              </a:xfrm>
              <a:custGeom>
                <a:avLst/>
                <a:gdLst>
                  <a:gd name="textAreaLeft" fmla="*/ 48600 w 75960"/>
                  <a:gd name="textAreaRight" fmla="*/ 76320 w 75960"/>
                  <a:gd name="textAreaTop" fmla="*/ 7920 h 304560"/>
                  <a:gd name="textAreaBottom" fmla="*/ 296640 h 304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Text Box 13"/>
              <p:cNvSpPr/>
              <p:nvPr/>
            </p:nvSpPr>
            <p:spPr>
              <a:xfrm rot="16200000">
                <a:off x="5770800" y="1846080"/>
                <a:ext cx="723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BE" sz="1200" spc="-1" strike="noStrike">
                    <a:solidFill>
                      <a:srgbClr val="000000"/>
                    </a:solidFill>
                    <a:latin typeface="Times New Roman"/>
                  </a:rPr>
                  <a:t>miR-659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AutoShape 28"/>
              <p:cNvSpPr/>
              <p:nvPr/>
            </p:nvSpPr>
            <p:spPr>
              <a:xfrm rot="5400000">
                <a:off x="6095520" y="2238480"/>
                <a:ext cx="75960" cy="304560"/>
              </a:xfrm>
              <a:custGeom>
                <a:avLst/>
                <a:gdLst>
                  <a:gd name="textAreaLeft" fmla="*/ 48600 w 75960"/>
                  <a:gd name="textAreaRight" fmla="*/ 76320 w 75960"/>
                  <a:gd name="textAreaTop" fmla="*/ 7920 h 304560"/>
                  <a:gd name="textAreaBottom" fmla="*/ 296640 h 304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5400" y="10800"/>
                      <a:pt x="0" y="10800"/>
                    </a:cubicBezTo>
                    <a:cubicBezTo>
                      <a:pt x="54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87" name="Rectangle 9"/>
          <p:cNvSpPr/>
          <p:nvPr/>
        </p:nvSpPr>
        <p:spPr>
          <a:xfrm>
            <a:off x="468360" y="2852640"/>
            <a:ext cx="431640" cy="18716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ZoneTexte 8"/>
          <p:cNvSpPr/>
          <p:nvPr/>
        </p:nvSpPr>
        <p:spPr>
          <a:xfrm rot="16200000">
            <a:off x="-268200" y="3620520"/>
            <a:ext cx="190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400" spc="-1" strike="noStrike">
                <a:solidFill>
                  <a:srgbClr val="000000"/>
                </a:solidFill>
                <a:latin typeface="Times New Roman"/>
              </a:rPr>
              <a:t>Expression ratios (log2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3T13:48:03Z</dcterms:created>
  <dc:creator>hebrant</dc:creator>
  <dc:description/>
  <dc:language>en-US</dc:language>
  <cp:lastModifiedBy>aline</cp:lastModifiedBy>
  <dcterms:modified xsi:type="dcterms:W3CDTF">2014-01-28T10:01:08Z</dcterms:modified>
  <cp:revision>11</cp:revision>
  <dc:subject/>
  <dc:title>Présentation PowerPoint</dc:title>
</cp:coreProperties>
</file>